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76" d="100"/>
          <a:sy n="76" d="100"/>
        </p:scale>
        <p:origin x="-1206" y="21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4F9611-C504-D042-9FC9-7F1E3A913BD1}" type="datetimeFigureOut">
              <a:rPr lang="en-US" smtClean="0"/>
              <a:t>3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91817-330B-B345-A176-02FDFAE875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39486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4F9611-C504-D042-9FC9-7F1E3A913BD1}" type="datetimeFigureOut">
              <a:rPr lang="en-US" smtClean="0"/>
              <a:t>3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91817-330B-B345-A176-02FDFAE875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18210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4F9611-C504-D042-9FC9-7F1E3A913BD1}" type="datetimeFigureOut">
              <a:rPr lang="en-US" smtClean="0"/>
              <a:t>3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91817-330B-B345-A176-02FDFAE875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27036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4F9611-C504-D042-9FC9-7F1E3A913BD1}" type="datetimeFigureOut">
              <a:rPr lang="en-US" smtClean="0"/>
              <a:t>3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91817-330B-B345-A176-02FDFAE875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02096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4F9611-C504-D042-9FC9-7F1E3A913BD1}" type="datetimeFigureOut">
              <a:rPr lang="en-US" smtClean="0"/>
              <a:t>3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91817-330B-B345-A176-02FDFAE875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41346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4F9611-C504-D042-9FC9-7F1E3A913BD1}" type="datetimeFigureOut">
              <a:rPr lang="en-US" smtClean="0"/>
              <a:t>3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91817-330B-B345-A176-02FDFAE875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17643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4F9611-C504-D042-9FC9-7F1E3A913BD1}" type="datetimeFigureOut">
              <a:rPr lang="en-US" smtClean="0"/>
              <a:t>3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91817-330B-B345-A176-02FDFAE875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99994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4F9611-C504-D042-9FC9-7F1E3A913BD1}" type="datetimeFigureOut">
              <a:rPr lang="en-US" smtClean="0"/>
              <a:t>3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91817-330B-B345-A176-02FDFAE875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1720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4F9611-C504-D042-9FC9-7F1E3A913BD1}" type="datetimeFigureOut">
              <a:rPr lang="en-US" smtClean="0"/>
              <a:t>3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91817-330B-B345-A176-02FDFAE875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03706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4F9611-C504-D042-9FC9-7F1E3A913BD1}" type="datetimeFigureOut">
              <a:rPr lang="en-US" smtClean="0"/>
              <a:t>3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91817-330B-B345-A176-02FDFAE875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24052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4F9611-C504-D042-9FC9-7F1E3A913BD1}" type="datetimeFigureOut">
              <a:rPr lang="en-US" smtClean="0"/>
              <a:t>3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91817-330B-B345-A176-02FDFAE875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792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4F9611-C504-D042-9FC9-7F1E3A913BD1}" type="datetimeFigureOut">
              <a:rPr lang="en-US" smtClean="0"/>
              <a:t>3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A91817-330B-B345-A176-02FDFAE875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194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687102" y="5979526"/>
            <a:ext cx="633137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upplemental Figure 1:</a:t>
            </a:r>
            <a:r>
              <a:rPr lang="en-US" dirty="0"/>
              <a:t> Brain MRI at 11 years of age </a:t>
            </a:r>
            <a:r>
              <a:rPr lang="en-US" dirty="0" smtClean="0"/>
              <a:t>pre-liver transplant showing </a:t>
            </a:r>
            <a:r>
              <a:rPr lang="en-US" dirty="0"/>
              <a:t>bilateral </a:t>
            </a:r>
            <a:r>
              <a:rPr lang="en-US" dirty="0" smtClean="0"/>
              <a:t>T2 </a:t>
            </a:r>
            <a:r>
              <a:rPr lang="en-US" dirty="0" err="1" smtClean="0"/>
              <a:t>hyperintensities</a:t>
            </a:r>
            <a:r>
              <a:rPr lang="en-US" dirty="0" smtClean="0"/>
              <a:t> in the striatum. </a:t>
            </a:r>
            <a:endParaRPr lang="en-US" dirty="0"/>
          </a:p>
        </p:txBody>
      </p:sp>
      <p:pic>
        <p:nvPicPr>
          <p:cNvPr id="2" name="Picture 1" descr="BerryMRIFig1.tif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7300" y="736600"/>
            <a:ext cx="6629400" cy="5372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101003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21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BC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dem Demirbas</dc:creator>
  <cp:lastModifiedBy>007454</cp:lastModifiedBy>
  <cp:revision>2</cp:revision>
  <dcterms:created xsi:type="dcterms:W3CDTF">2020-01-24T16:49:13Z</dcterms:created>
  <dcterms:modified xsi:type="dcterms:W3CDTF">2020-03-25T01:49:49Z</dcterms:modified>
</cp:coreProperties>
</file>